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59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8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A99E646D-C4A7-43F3-A82D-F26C55212C22}"/>
    <pc:docChg chg="delSld modSld">
      <pc:chgData name="Najafi, Allison" userId="0304a55d-1748-4b32-895c-375cbdec2d3f" providerId="ADAL" clId="{A99E646D-C4A7-43F3-A82D-F26C55212C22}" dt="2025-02-12T22:48:03.771" v="9" actId="6549"/>
      <pc:docMkLst>
        <pc:docMk/>
      </pc:docMkLst>
      <pc:sldChg chg="del">
        <pc:chgData name="Najafi, Allison" userId="0304a55d-1748-4b32-895c-375cbdec2d3f" providerId="ADAL" clId="{A99E646D-C4A7-43F3-A82D-F26C55212C22}" dt="2025-01-27T21:35:48.193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A99E646D-C4A7-43F3-A82D-F26C55212C22}" dt="2025-01-27T21:35:48.879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A99E646D-C4A7-43F3-A82D-F26C55212C22}" dt="2025-01-27T21:35:49.895" v="3" actId="47"/>
        <pc:sldMkLst>
          <pc:docMk/>
          <pc:sldMk cId="2505032853" sldId="258"/>
        </pc:sldMkLst>
      </pc:sldChg>
      <pc:sldChg chg="modSp mod">
        <pc:chgData name="Najafi, Allison" userId="0304a55d-1748-4b32-895c-375cbdec2d3f" providerId="ADAL" clId="{A99E646D-C4A7-43F3-A82D-F26C55212C22}" dt="2025-02-12T22:48:03.771" v="9" actId="6549"/>
        <pc:sldMkLst>
          <pc:docMk/>
          <pc:sldMk cId="2305346892" sldId="259"/>
        </pc:sldMkLst>
        <pc:graphicFrameChg chg="modGraphic">
          <ac:chgData name="Najafi, Allison" userId="0304a55d-1748-4b32-895c-375cbdec2d3f" providerId="ADAL" clId="{A99E646D-C4A7-43F3-A82D-F26C55212C22}" dt="2025-02-12T22:48:03.771" v="9" actId="6549"/>
          <ac:graphicFrameMkLst>
            <pc:docMk/>
            <pc:sldMk cId="2305346892" sldId="259"/>
            <ac:graphicFrameMk id="5" creationId="{CAD71C61-667F-0A3C-1F23-D7807187877B}"/>
          </ac:graphicFrameMkLst>
        </pc:graphicFrameChg>
      </pc:sldChg>
      <pc:sldChg chg="del">
        <pc:chgData name="Najafi, Allison" userId="0304a55d-1748-4b32-895c-375cbdec2d3f" providerId="ADAL" clId="{A99E646D-C4A7-43F3-A82D-F26C55212C22}" dt="2025-01-27T21:35:49.352" v="2" actId="47"/>
        <pc:sldMkLst>
          <pc:docMk/>
          <pc:sldMk cId="2192517872" sldId="260"/>
        </pc:sldMkLst>
      </pc:sldChg>
      <pc:sldChg chg="del">
        <pc:chgData name="Najafi, Allison" userId="0304a55d-1748-4b32-895c-375cbdec2d3f" providerId="ADAL" clId="{A99E646D-C4A7-43F3-A82D-F26C55212C22}" dt="2025-01-27T21:35:51.244" v="5" actId="47"/>
        <pc:sldMkLst>
          <pc:docMk/>
          <pc:sldMk cId="3507118384" sldId="262"/>
        </pc:sldMkLst>
      </pc:sldChg>
      <pc:sldChg chg="del">
        <pc:chgData name="Najafi, Allison" userId="0304a55d-1748-4b32-895c-375cbdec2d3f" providerId="ADAL" clId="{A99E646D-C4A7-43F3-A82D-F26C55212C22}" dt="2025-01-27T21:35:52.606" v="6" actId="47"/>
        <pc:sldMkLst>
          <pc:docMk/>
          <pc:sldMk cId="3515496556" sldId="263"/>
        </pc:sldMkLst>
      </pc:sldChg>
      <pc:sldChg chg="del">
        <pc:chgData name="Najafi, Allison" userId="0304a55d-1748-4b32-895c-375cbdec2d3f" providerId="ADAL" clId="{A99E646D-C4A7-43F3-A82D-F26C55212C22}" dt="2025-01-27T21:35:54.523" v="7" actId="47"/>
        <pc:sldMkLst>
          <pc:docMk/>
          <pc:sldMk cId="2264077816" sldId="264"/>
        </pc:sldMkLst>
      </pc:sldChg>
      <pc:sldChg chg="del">
        <pc:chgData name="Najafi, Allison" userId="0304a55d-1748-4b32-895c-375cbdec2d3f" providerId="ADAL" clId="{A99E646D-C4A7-43F3-A82D-F26C55212C22}" dt="2025-01-27T21:35:55.005" v="8" actId="47"/>
        <pc:sldMkLst>
          <pc:docMk/>
          <pc:sldMk cId="639073537" sldId="265"/>
        </pc:sldMkLst>
      </pc:sldChg>
      <pc:sldChg chg="del">
        <pc:chgData name="Najafi, Allison" userId="0304a55d-1748-4b32-895c-375cbdec2d3f" providerId="ADAL" clId="{A99E646D-C4A7-43F3-A82D-F26C55212C22}" dt="2025-01-27T21:35:50.443" v="4" actId="47"/>
        <pc:sldMkLst>
          <pc:docMk/>
          <pc:sldMk cId="1558034745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AD71C61-667F-0A3C-1F23-D780718787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3406869"/>
              </p:ext>
            </p:extLst>
          </p:nvPr>
        </p:nvGraphicFramePr>
        <p:xfrm>
          <a:off x="1231580" y="624873"/>
          <a:ext cx="4394840" cy="5802319"/>
        </p:xfrm>
        <a:graphic>
          <a:graphicData uri="http://schemas.openxmlformats.org/drawingml/2006/table">
            <a:tbl>
              <a:tblPr firstRow="1" firstCol="1" bandRow="1"/>
              <a:tblGrid>
                <a:gridCol w="649147">
                  <a:extLst>
                    <a:ext uri="{9D8B030D-6E8A-4147-A177-3AD203B41FA5}">
                      <a16:colId xmlns:a16="http://schemas.microsoft.com/office/drawing/2014/main" val="4195193760"/>
                    </a:ext>
                  </a:extLst>
                </a:gridCol>
                <a:gridCol w="1232331">
                  <a:extLst>
                    <a:ext uri="{9D8B030D-6E8A-4147-A177-3AD203B41FA5}">
                      <a16:colId xmlns:a16="http://schemas.microsoft.com/office/drawing/2014/main" val="3277999071"/>
                    </a:ext>
                  </a:extLst>
                </a:gridCol>
                <a:gridCol w="579485">
                  <a:extLst>
                    <a:ext uri="{9D8B030D-6E8A-4147-A177-3AD203B41FA5}">
                      <a16:colId xmlns:a16="http://schemas.microsoft.com/office/drawing/2014/main" val="14780703"/>
                    </a:ext>
                  </a:extLst>
                </a:gridCol>
                <a:gridCol w="752715">
                  <a:extLst>
                    <a:ext uri="{9D8B030D-6E8A-4147-A177-3AD203B41FA5}">
                      <a16:colId xmlns:a16="http://schemas.microsoft.com/office/drawing/2014/main" val="1969951354"/>
                    </a:ext>
                  </a:extLst>
                </a:gridCol>
                <a:gridCol w="591814">
                  <a:extLst>
                    <a:ext uri="{9D8B030D-6E8A-4147-A177-3AD203B41FA5}">
                      <a16:colId xmlns:a16="http://schemas.microsoft.com/office/drawing/2014/main" val="133438465"/>
                    </a:ext>
                  </a:extLst>
                </a:gridCol>
                <a:gridCol w="589348">
                  <a:extLst>
                    <a:ext uri="{9D8B030D-6E8A-4147-A177-3AD203B41FA5}">
                      <a16:colId xmlns:a16="http://schemas.microsoft.com/office/drawing/2014/main" val="3370815763"/>
                    </a:ext>
                  </a:extLst>
                </a:gridCol>
              </a:tblGrid>
              <a:tr h="308308">
                <a:tc grid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807544"/>
                  </a:ext>
                </a:extLst>
              </a:tr>
              <a:tr h="1611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9486846"/>
                  </a:ext>
                </a:extLst>
              </a:tr>
              <a:tr h="308308">
                <a:tc grid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0572178"/>
                  </a:ext>
                </a:extLst>
              </a:tr>
              <a:tr h="26123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bs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ffect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nit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ddsRatioEst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owerCL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UpperCL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1201865"/>
                  </a:ext>
                </a:extLst>
              </a:tr>
              <a:tr h="3390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       GreenLight vs PUL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4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1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58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5564736"/>
                  </a:ext>
                </a:extLst>
              </a:tr>
              <a:tr h="3390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eatment          TURP       vs PUL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0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8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52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488204"/>
                  </a:ext>
                </a:extLst>
              </a:tr>
              <a:tr h="1667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ARI use prior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0.3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3.88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9.62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0031366"/>
                  </a:ext>
                </a:extLst>
              </a:tr>
              <a:tr h="1667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phaBlock use prior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6.41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0.75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3.54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1339122"/>
                  </a:ext>
                </a:extLst>
              </a:tr>
              <a:tr h="1667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Chol use prior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88.29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5.82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4.10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663847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eta3agonist use prior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999.99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999.99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999.99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1819548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E5 use prior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8.9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1.28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7.27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2362371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0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0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1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6046309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diabetes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9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3691875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MI cat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10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7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9179387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e-index cystoscopy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1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8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319118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pelvic_pain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962538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bladder_neck_ob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9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6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3485811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ladder_disorder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4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6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3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2829411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erec_dy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0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8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4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6218797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IrrSypLUT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34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5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6162631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OBSSYMPLUT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8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5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0389843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oth_urin_sypm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1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23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5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3437574"/>
                  </a:ext>
                </a:extLst>
              </a:tr>
              <a:tr h="16674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prostatiti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0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2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0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2627028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urinary_Calculus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49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6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8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514240"/>
                  </a:ext>
                </a:extLst>
              </a:tr>
              <a:tr h="227882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 urinary_Retention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12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97</a:t>
                      </a:r>
                      <a:endParaRPr lang="en-US" sz="100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solidFill>
                            <a:srgbClr val="000000"/>
                          </a:solidFill>
                          <a:effectLst/>
                          <a:highlight>
                            <a:srgbClr val="FFFFFF"/>
                          </a:highlight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27</a:t>
                      </a:r>
                      <a:endParaRPr lang="en-US" sz="1000" dirty="0"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027" marR="600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24466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5346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7</TotalTime>
  <Words>182</Words>
  <Application>Microsoft Office PowerPoint</Application>
  <PresentationFormat>Letter Paper (8.5x11 in)</PresentationFormat>
  <Paragraphs>1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2-12T22:4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